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28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408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334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01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592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244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45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234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22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152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698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880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3559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6BB13-9079-4554-8034-26A60E5804BD}" type="datetimeFigureOut">
              <a:rPr kumimoji="1" lang="ja-JP" altLang="en-US" smtClean="0"/>
              <a:t>2020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225E8-35BB-42B8-A556-984C057490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29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66069" y="1207911"/>
            <a:ext cx="8834438" cy="5756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Relative risk of cervical cancer among females born in FY2004 – if the governmental recommendation restarted in FY2020 = (Rate of cervical cancer that cannot be prevented with HPV vaccine) + (Rate of cervical cancer that can be prevented with HPV vaccine) x (Rate of girls unprotected by HPV vaccine who were born in FY2004) / (Rate of girls unprotected by HPV vaccine who were born in FY1993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ja-JP" altLang="ja-JP" sz="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Rate of girls unprotected by HPV vaccine who were born in FY2004 = ( Non-inoculation rate at 12 years old) x (sexual experience rate at 12 years old) +  ( Non-inoculation rate at 13 years old) x (sexual experience rate at 13 years old) + (non-inoculation rate at 14 years old ) x (new sexual experience rate at 14 years old) + (non-inoculation rate at 15 years old) × (New sexual experience rate at 15 years old) + (Non-inoculation rate at 16 years old) × (New sexual experience rate at 16 years old) + (Non-inoculation rate during lifetime) × (New sexual experience rate during lifetime)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ja-JP" altLang="ja-JP" sz="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Rate of girls unprotected by HPV vaccine who were born in FY1993 = (Lifetime non-inoculation rate) x (Lifetime sexual experience rate)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ja-JP" altLang="ja-JP" sz="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, 2, and 3. 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ate = 0.4 + 0.6 x ((1-0.002) x 0 + (1-0.0013) x 0.01 + (1-0) x (0.02-0.01) + (1-0) x (0.05-0.02) + (1-0.6878) x (0.15-0.05) +(1-0.6879) x (0.85-0.15 )) / 1 x 0.85 = 0.611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. 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risk of cervical cancer to be fixed in place if the governmental recommendation is not resumed in FY2020 = (Relative risk of cervical cancer among those born in FY2004 - if the governmental recommendation is resumed in FY2021, as calculated in the same way as 1, 2 and 3) - (Relative risk of cervical cancer among those born in FY2004 - if the governmental recommendation is resumed in FY2020) </a:t>
            </a:r>
            <a:endParaRPr lang="ja-JP" altLang="ja-JP" sz="10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ate = 0.999-0.611 = 0.388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ja-JP" altLang="ja-JP" sz="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. 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mber of females with cervical cancer fixed per day in place in FY2020 among females born in FY2004 = (Relative risk of cervical cancer to be fixed if the governmental recommendation is not resumed in FY2020) × (Nationwide cervical cancer cases estimated from the Regional cancer registry) / 365 </a:t>
            </a:r>
            <a:endParaRPr lang="ja-JP" altLang="ja-JP" sz="10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number (per day)= 0.388 × 11293 / 365 = 12.0 </a:t>
            </a:r>
            <a:endParaRPr lang="ja-JP" altLang="ja-JP" sz="10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0" y="957687"/>
            <a:ext cx="92343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example of calculation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estimation of increased numbers of cervical cancer patients fixed in FY2020 among those born in FY2004.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54781" y="1275644"/>
            <a:ext cx="8834438" cy="54614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966D551-4CC7-49C7-911D-C5A0479757BF}"/>
              </a:ext>
            </a:extLst>
          </p:cNvPr>
          <p:cNvSpPr txBox="1"/>
          <p:nvPr/>
        </p:nvSpPr>
        <p:spPr>
          <a:xfrm>
            <a:off x="11288" y="129149"/>
            <a:ext cx="914400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Potential for cervical cancer incidence and death resulting from Japan’s current policy of prolonged suspension of its governmental recommendation of the HPV vaccine</a:t>
            </a: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: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ami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agi, BFA, Yutaka Ueda, MD, PhD, Satoshi Nakagawa, MD, PhD, Sayaka Ikeda, MD, Yusuke Tanaka, MD, PhD, Masayuki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kine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, Etsuko Miyagi, MD, PhD, Takayuki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moto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, Tadashi Kimura, MD, PhD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</a:p>
        </p:txBody>
      </p:sp>
    </p:spTree>
    <p:extLst>
      <p:ext uri="{BB962C8B-B14F-4D97-AF65-F5344CB8AC3E}">
        <p14:creationId xmlns:p14="http://schemas.microsoft.com/office/powerpoint/2010/main" val="1802828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557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taka Ueda</dc:creator>
  <cp:lastModifiedBy>上田 豊</cp:lastModifiedBy>
  <cp:revision>11</cp:revision>
  <dcterms:created xsi:type="dcterms:W3CDTF">2020-09-01T09:07:45Z</dcterms:created>
  <dcterms:modified xsi:type="dcterms:W3CDTF">2020-09-04T10:51:30Z</dcterms:modified>
</cp:coreProperties>
</file>